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2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72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9974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9538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2330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1952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6782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6783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3946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0780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2689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4819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3438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9BF28-65AB-4348-BD2A-25EF4C4117CC}" type="datetimeFigureOut">
              <a:rPr lang="en-GB" smtClean="0"/>
              <a:t>05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EABE6-55A3-486A-BB93-6D4A21C579A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5074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219" y="246184"/>
            <a:ext cx="6498951" cy="1081453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71219" y="11086862"/>
            <a:ext cx="6498951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able 3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GB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s of functional and cognitive status, and behavioural and constitutional symptoms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234824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6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ghenekome Gibinigie</dc:creator>
  <cp:lastModifiedBy>Oghenekome Gibinigie</cp:lastModifiedBy>
  <cp:revision>4</cp:revision>
  <dcterms:created xsi:type="dcterms:W3CDTF">2017-04-11T11:08:28Z</dcterms:created>
  <dcterms:modified xsi:type="dcterms:W3CDTF">2017-12-05T17:08:29Z</dcterms:modified>
</cp:coreProperties>
</file>